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Wenjie (wenjiew@uidaho.edu)" initials="WW(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5D2A5"/>
    <a:srgbClr val="F331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3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8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5555D-255F-419C-B9E8-EF1DA07BFEA6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AC749-80BA-4A8D-96A7-27AC42E5B4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27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5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78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5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5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0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862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764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0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0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62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yAt 1B-GFP in rh1b mito579 fast_19_subB_crp_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contrast="30000"/>
          </a:blip>
          <a:stretch>
            <a:fillRect/>
          </a:stretch>
        </p:blipFill>
        <p:spPr>
          <a:xfrm>
            <a:off x="1368241" y="528994"/>
            <a:ext cx="4138863" cy="357551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6ED9293-417E-C140-BF1A-FAE0A2AAFA87}"/>
              </a:ext>
            </a:extLst>
          </p:cNvPr>
          <p:cNvSpPr/>
          <p:nvPr/>
        </p:nvSpPr>
        <p:spPr>
          <a:xfrm>
            <a:off x="930729" y="4409298"/>
            <a:ext cx="5020128" cy="7599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S1 Movie. Arabidopsis AtRNH1B is a mitochondrial RNase H1 protein.</a:t>
            </a:r>
            <a:endParaRPr lang="en-CN" sz="12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LiTone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LBS Light-sheet microscopy of root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pro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: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-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GFP atrnh1b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transgenic plants. Scale bars, 10μm. Green= GFP, Magenta=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itoTracker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</a:t>
            </a:r>
            <a:endParaRPr lang="en-CN" sz="12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51737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>
          <a:noFill/>
        </a:ln>
      </a:spPr>
      <a:bodyPr wrap="square" rtlCol="0">
        <a:spAutoFit/>
      </a:bodyPr>
      <a:lstStyle>
        <a:defPPr>
          <a:defRPr sz="10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58</TotalTime>
  <Words>39</Words>
  <Application>Microsoft Macintosh PowerPoint</Application>
  <PresentationFormat>A4 Paper (210x297 mm)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ll14@mails.tsinghua.edu.cn</dc:creator>
  <cp:lastModifiedBy>Q Sun</cp:lastModifiedBy>
  <cp:revision>161</cp:revision>
  <cp:lastPrinted>2020-08-24T06:21:32Z</cp:lastPrinted>
  <dcterms:created xsi:type="dcterms:W3CDTF">2019-11-01T09:30:31Z</dcterms:created>
  <dcterms:modified xsi:type="dcterms:W3CDTF">2021-07-12T09:46:31Z</dcterms:modified>
</cp:coreProperties>
</file>